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756"/>
    <p:restoredTop sz="95840"/>
  </p:normalViewPr>
  <p:slideViewPr>
    <p:cSldViewPr snapToGrid="0">
      <p:cViewPr varScale="1">
        <p:scale>
          <a:sx n="112" d="100"/>
          <a:sy n="112" d="100"/>
        </p:scale>
        <p:origin x="33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92D5F6-D847-833C-1CF3-69EC8AFD617E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31B2598-43D5-92B8-156F-D8B79C5BC2C2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8452CA6-ED55-DE1C-6B76-6CDCDA1DD3D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E503CC-1E93-BCC3-D20A-EAAE88B434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6ED767C-5350-BEFE-A075-60DDED218A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95819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F5F91F-DA51-8266-83AD-D577BAE0F1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564D50A8-D5B7-B031-99E6-5B768342C9A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FCD77BC-14B6-87AB-F1CB-9ACFE67317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1A2B87E-6CC0-FED8-DD99-41195D8D5D8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98F46CE-F103-07D4-2A63-31E79093C56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08666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92C4B0F-D356-EBDF-843B-FAA9CC070C2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2E3FB32-ACCB-C24C-6F3A-CBDB04E4884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0EC03FF-CD98-0788-6157-0B732D63E7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B7F38EF-3982-E7CF-1F68-4DDC51E058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FB085C8-4F60-C60F-D65C-AF88089B99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26818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7FFD2E2-6A84-5384-A001-7DAAF7E9B6C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1B6B9A1-69CE-8C78-D729-1C8EB564AD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1802B6-06B7-ADD7-8815-6D4A7ACD2E8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85B61DA-E21F-94D1-2135-1799EA4457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EAF9B0-7798-46BD-B239-30E5883364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4692287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B2986FF-A2F9-6C7F-4472-947C56E0543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080D38-321E-4170-0600-3B8F4126FFC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CAA9A3B-A499-C83C-D2D8-C69342684B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2A77FAE-A3A8-C792-8ACC-5B1E911167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979C13-C679-E6E6-7FD5-157B142E15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47034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73710F0-BCFE-7F89-B493-A9A0236B01E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EDF857-C524-6DF7-ACEC-741F0F4F3723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20518C5-DBA8-7907-E513-DAC0EE1C01E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9931F7CF-EF53-88F4-CB66-7EB91759A64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FB0BFE-EF92-8479-2239-DF3D05EFBB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6AFEBC0-C36F-4B74-0203-15F6A38678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23250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F5A44F-5B14-1B0C-933C-AE31DB400F5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8A3A9575-396C-98DC-115B-81F00F06BF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619140B-6AAA-C3F5-1ECD-07B9A2A5007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C33A99-4142-57DE-1FEA-58CDC3D0B95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332F766-CA0F-31BA-13C7-63CAC9C0F92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98DA1E3-71AE-168B-D1A9-9FBA17DDAB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1BA13F03-8019-0A7E-028F-311BAE2A7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3B8BE9E8-FB86-FF8B-7892-98AB936AD9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312153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6ADE4D-D2B5-01B8-EFEC-69A68807EA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C881A26D-7AC7-E7B1-943D-DC81E0A643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C699510-157D-2FDA-77C6-38952D0768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0532C395-51AD-58A2-B96F-43349CB553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219440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61A2152-7D1B-C30E-0234-FDE5E633C7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443FD1B-D036-2084-AF55-B147D7822F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12F629A-3D61-E872-9C2E-D2F16C1F47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40815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AE491CB-CE4D-1276-97AD-A6EFF09DD06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9D8F592-94BF-5583-C2AC-023B3FF30D6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70ACA86-ABC9-6977-7544-6513E7DA6AE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8A85CD7-5D40-B593-6B2B-B453BE9369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D839B00-4202-E563-1F35-0B664BF29DF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AB378AB-011D-8288-1912-48E5A506A01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464665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53F972B-1697-838C-8046-6450E1E235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BE65F4EC-9A24-B2C5-030F-F54E36C5C78D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CD616F13-30A2-124A-F332-12564E0A02C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93B76B4-1F1F-E2D8-1136-B4CB431190D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2C4E0B-08FF-5F30-5171-EFB6A3F29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8B8DDA3-27AD-846E-8EEB-8C5F2002DA4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564638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A974D68D-8D5E-40D2-8DFE-79C67298048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2A1D0AE-1ECF-C773-A549-EF988CAB8CD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400BA28-A29D-23EB-F025-1C7EC8B7A354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E7113FB-95BF-3643-807B-79532B092E12}" type="datetimeFigureOut">
              <a:rPr lang="en-US" smtClean="0"/>
              <a:t>8/17/23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132E8F-3E79-EDFE-7B9C-94901D7D1D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C100CB8-72A6-86BB-506F-BD8490E1920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A85F5C3-952B-2A43-84CC-05DA75A5E97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063548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311B2C81-5AAB-2600-673D-427DA281B44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745" t="492" r="5575" b="4297"/>
          <a:stretch/>
        </p:blipFill>
        <p:spPr>
          <a:xfrm>
            <a:off x="342900" y="811531"/>
            <a:ext cx="10669905" cy="579617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212A3D3D-0239-E8F7-AD94-D395353CBF55}"/>
              </a:ext>
            </a:extLst>
          </p:cNvPr>
          <p:cNvSpPr txBox="1"/>
          <p:nvPr/>
        </p:nvSpPr>
        <p:spPr>
          <a:xfrm>
            <a:off x="-104775" y="0"/>
            <a:ext cx="12401550" cy="73866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1400" dirty="0">
                <a:solidFill>
                  <a:srgbClr val="000000"/>
                </a:solidFill>
                <a:latin typeface="+mj-lt"/>
              </a:rPr>
              <a:t>Figure S2: Results from group ICA from three scanners and two sessions from each scanner. Paired wise t-test was performed between sessions of each scanner.  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+mj-lt"/>
              </a:rPr>
              <a:t>Each pair of thumbnails corresponds network matrix and the node numbers are listed in the text captions. The coloured bar joining each pair of nodes tells the overall group-average connection strength and the "value" numbers is 1-p-values which is not significant in any of these (&gt;0.95) after multiple corrections. </a:t>
            </a:r>
            <a:endParaRPr lang="en-US" sz="1400" dirty="0">
              <a:latin typeface="+mj-lt"/>
            </a:endParaRPr>
          </a:p>
        </p:txBody>
      </p:sp>
    </p:spTree>
    <p:extLst>
      <p:ext uri="{BB962C8B-B14F-4D97-AF65-F5344CB8AC3E}">
        <p14:creationId xmlns:p14="http://schemas.microsoft.com/office/powerpoint/2010/main" val="366246563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09</TotalTime>
  <Words>83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jiha Bano</dc:creator>
  <cp:lastModifiedBy>Wajiha Bano</cp:lastModifiedBy>
  <cp:revision>4</cp:revision>
  <dcterms:created xsi:type="dcterms:W3CDTF">2023-05-06T05:30:42Z</dcterms:created>
  <dcterms:modified xsi:type="dcterms:W3CDTF">2023-08-17T14:31:53Z</dcterms:modified>
</cp:coreProperties>
</file>